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45" d="100"/>
          <a:sy n="45" d="100"/>
        </p:scale>
        <p:origin x="24" y="9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AB871-543E-464C-B963-958B76B5126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996EF-F72E-4ECA-AA57-391B046624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2082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AB871-543E-464C-B963-958B76B5126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996EF-F72E-4ECA-AA57-391B046624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4482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AB871-543E-464C-B963-958B76B5126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996EF-F72E-4ECA-AA57-391B046624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389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AB871-543E-464C-B963-958B76B5126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996EF-F72E-4ECA-AA57-391B046624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040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AB871-543E-464C-B963-958B76B5126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996EF-F72E-4ECA-AA57-391B046624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616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AB871-543E-464C-B963-958B76B5126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996EF-F72E-4ECA-AA57-391B046624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89458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AB871-543E-464C-B963-958B76B5126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996EF-F72E-4ECA-AA57-391B046624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03752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AB871-543E-464C-B963-958B76B5126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996EF-F72E-4ECA-AA57-391B046624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5359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AB871-543E-464C-B963-958B76B5126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996EF-F72E-4ECA-AA57-391B046624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021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AB871-543E-464C-B963-958B76B5126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996EF-F72E-4ECA-AA57-391B046624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4421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2AB871-543E-464C-B963-958B76B5126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6996EF-F72E-4ECA-AA57-391B046624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4532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AB871-543E-464C-B963-958B76B5126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6996EF-F72E-4ECA-AA57-391B046624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8981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3737" y="435428"/>
            <a:ext cx="9551126" cy="5432516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1574800" y="5867944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20.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µM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, nM) for biquinolines against sensitive strain W2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67682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10:31Z</dcterms:created>
  <dcterms:modified xsi:type="dcterms:W3CDTF">2020-08-04T16:35:12Z</dcterms:modified>
</cp:coreProperties>
</file>